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F9F36-72C6-41D0-ACAC-EDA499762E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85916-88E0-4E97-A3B2-70E8A99964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B034D-B200-4280-9C9C-78810A0E0A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E5530-9A57-43FB-BACD-45B842D90B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AC475-0FE0-477B-AFD2-731F2BCABE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1CCA8-74E7-4CFA-ADFB-3EDCF0966A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35799-84C0-48D7-8721-B7967089F9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64AA58-E1CA-4443-A600-097C88AE59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807F3-AFA1-420D-9E69-FD7D079A1B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77BB9-2664-48E3-9B7F-3E7EC59ADB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61B49-B35E-4BC6-BBAE-3A8755671F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4721C-9F0F-42FB-819F-F60B2EA237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93B8AB-0C99-4E43-B282-48AEFB40E3C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"/>
          <p:cNvSpPr/>
          <p:nvPr/>
        </p:nvSpPr>
        <p:spPr>
          <a:xfrm>
            <a:off x="457200" y="395280"/>
            <a:ext cx="60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 Transcripts* and the SNPs in their neighboring regio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609480" y="762120"/>
          <a:ext cx="4572000" cy="2827080"/>
        </p:xfrm>
        <a:graphic>
          <a:graphicData uri="http://schemas.openxmlformats.org/drawingml/2006/table">
            <a:tbl>
              <a:tblPr/>
              <a:tblGrid>
                <a:gridCol w="1143000"/>
                <a:gridCol w="598680"/>
                <a:gridCol w="654120"/>
                <a:gridCol w="652320"/>
                <a:gridCol w="544680"/>
                <a:gridCol w="544320"/>
                <a:gridCol w="434880"/>
              </a:tblGrid>
              <a:tr h="314280">
                <a:tc rowSpan="2"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 of SNP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 the reg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ze of the neighboring region (kb)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18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,3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9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68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4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09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7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6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,5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,0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3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3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45 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 Box 3"/>
          <p:cNvSpPr/>
          <p:nvPr/>
        </p:nvSpPr>
        <p:spPr>
          <a:xfrm>
            <a:off x="609480" y="3657600"/>
            <a:ext cx="563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23,484 transcrip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   Number of thousands of nucleotides upstream and downstream of each transcrip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* SNP overlaps with the transcrip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7T18:58:03Z</dcterms:created>
  <dc:creator>cxu</dc:creator>
  <dc:description/>
  <dc:language>en-US</dc:language>
  <cp:lastModifiedBy> </cp:lastModifiedBy>
  <dcterms:modified xsi:type="dcterms:W3CDTF">2010-06-09T13:59:25Z</dcterms:modified>
  <cp:revision>136</cp:revision>
  <dc:subject/>
  <dc:title>Slide 1</dc:title>
</cp:coreProperties>
</file>